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7" r:id="rId2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54" autoAdjust="0"/>
    <p:restoredTop sz="94660"/>
  </p:normalViewPr>
  <p:slideViewPr>
    <p:cSldViewPr snapToGrid="0">
      <p:cViewPr>
        <p:scale>
          <a:sx n="130" d="100"/>
          <a:sy n="130" d="100"/>
        </p:scale>
        <p:origin x="1986" y="-17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9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446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474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602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3434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139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8935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673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961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8530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2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105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98D1E82-94E7-524C-B5DB-3D3BB4740409}"/>
              </a:ext>
            </a:extLst>
          </p:cNvPr>
          <p:cNvSpPr txBox="1"/>
          <p:nvPr/>
        </p:nvSpPr>
        <p:spPr>
          <a:xfrm>
            <a:off x="137160" y="6713770"/>
            <a:ext cx="658368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S2 Fig. Brain cytokine responses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Cytokines were assessed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in homogenized brain tissue by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a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22-plex rat-specific </a:t>
            </a:r>
            <a:r>
              <a:rPr lang="en-US" sz="1100" dirty="0" err="1" smtClean="0">
                <a:latin typeface="Arial" charset="0"/>
                <a:ea typeface="Arial" charset="0"/>
                <a:cs typeface="Arial" charset="0"/>
              </a:rPr>
              <a:t>Luminex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kit.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CTL represents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mock-infected rats.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For statistical analysis, 2-way ANOVA with multiple comparisons was performed (see Methods section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).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The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# in the bottom right corner indicates significance by 2-way ANOVA (N.S., not significant; #, P &lt; 0.05; ##, P &lt; 0.01; ###, P &lt; 0.001; ####, P &lt; 0.0001); asterisks above symbols indicate significance of individual time points compared to uninfected (*, P &lt; 0.05; **, P &lt; 0.01; ***, P &lt; 0.001; ****, P &lt; 0.0001). Asterisk above a bar indicates significance over the encompassed data points.</a:t>
            </a:r>
          </a:p>
          <a:p>
            <a:endParaRPr lang="en-US" sz="11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35366"/>
            <a:ext cx="6858000" cy="58042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70021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</TotalTime>
  <Words>124</Words>
  <Application>Microsoft Office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enter for Vaccine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tman, Amy Lynn</dc:creator>
  <cp:lastModifiedBy>Hartman, Amy Lynn</cp:lastModifiedBy>
  <cp:revision>14</cp:revision>
  <cp:lastPrinted>2019-04-18T16:17:53Z</cp:lastPrinted>
  <dcterms:created xsi:type="dcterms:W3CDTF">2019-04-16T18:48:22Z</dcterms:created>
  <dcterms:modified xsi:type="dcterms:W3CDTF">2019-04-23T13:19:12Z</dcterms:modified>
</cp:coreProperties>
</file>